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-1446" y="-7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988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534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8" cy="780097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71476" y="366714"/>
            <a:ext cx="4849813" cy="780097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23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808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0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722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71477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97302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773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38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920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207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2" y="273051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025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368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502883-220D-4040-B5E6-2820BB197C84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4508DE-172E-4B1E-B6CF-22788CD8635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92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 5"/>
          <p:cNvGrpSpPr/>
          <p:nvPr/>
        </p:nvGrpSpPr>
        <p:grpSpPr>
          <a:xfrm>
            <a:off x="1554406" y="188640"/>
            <a:ext cx="7056785" cy="6516146"/>
            <a:chOff x="1554406" y="188640"/>
            <a:chExt cx="7056785" cy="6516146"/>
          </a:xfrm>
        </p:grpSpPr>
        <p:sp>
          <p:nvSpPr>
            <p:cNvPr id="4" name="Rectangle 3"/>
            <p:cNvSpPr/>
            <p:nvPr/>
          </p:nvSpPr>
          <p:spPr>
            <a:xfrm>
              <a:off x="1554406" y="4581128"/>
              <a:ext cx="7056785" cy="212365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1. Influence of EBL cell density, yeast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NA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and adhesion on </a:t>
              </a:r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bovis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ytotoxicity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BL cells were seeded at different cell densities (cells/cm</a:t>
              </a:r>
              <a:r>
                <a:rPr lang="en-US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in DMEM-based medium supplemented with 10 µg/mL calf thymus DNA and inoculated with a collection of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bovi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train at an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I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2 (A). After 72 hours of co-incubation, monolayers were stained with crystal violet and survival cells were estimated by measuring the optical density at 590 nm (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D590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Yeast tRNAs, alone or in combination with calf thymus DNA, had only a limited influence on the cytotoxicity of RM16 for EBL cells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. RM16 cytotoxicity was determined after 72 hours co-incubation with EBL cells (10</a:t>
              </a:r>
              <a:r>
                <a:rPr lang="en-US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/cm</a:t>
              </a:r>
              <a:r>
                <a:rPr lang="en-US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in the presence of increasing concentration of yeast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N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/or calf thymus DNA. Close contact of RM16 to EBL cells is not required for cytotoxicity (C). Cytotoxicity of gentamicin-treated cell culture supernatants collected after 72 hours of co-incubation with RM16. Cell culture supernatants were treated by catalase to inactivate H</a:t>
              </a:r>
              <a:r>
                <a:rPr lang="en-US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Catalase) or centrifuged to deplete mycoplasma cells (centrifugation).</a:t>
              </a:r>
              <a:endParaRPr lang="fr-FR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6208" y="188640"/>
              <a:ext cx="6913181" cy="42530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08641850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97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Ecole Nationale Vétérinaire de Toulous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 Baranowski</dc:creator>
  <cp:lastModifiedBy>Eric Baranowski</cp:lastModifiedBy>
  <cp:revision>1</cp:revision>
  <dcterms:created xsi:type="dcterms:W3CDTF">2019-08-12T15:09:38Z</dcterms:created>
  <dcterms:modified xsi:type="dcterms:W3CDTF">2019-08-12T15:12:29Z</dcterms:modified>
</cp:coreProperties>
</file>